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27082-E49B-49D8-8EAE-A12E31FE12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6F9334-50B6-44AD-A8AB-E96DC73F42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5CE020-4FE8-4A9F-8E63-E53CF40B524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1B5FC-FE26-4BD3-B369-6A9E7AC339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0A2F31-CF14-4CE4-9576-C9B4FD72B9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369FE-722E-4519-B56E-399D2EE616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9C9E2B-0AD3-4BA8-B7D2-2966D773A3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2D2CE7-9D6B-4105-8827-54203B2458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A8EC3-2198-4300-A539-F8248EE28F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DEC12-B27D-4C84-AC22-2394EAAC3F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E8E93-5DF3-4C48-9AE8-52654AB234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CD3F3-8A00-4471-8EC2-9BC616BDED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9BC1DF-8514-4E70-B9F5-276B624C09B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80880" y="-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upplemental Table S1</a:t>
            </a:r>
            <a:br>
              <a:rPr sz="2800"/>
            </a:b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Primer/Probe Sequences for Quantitative RT PCR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371600" y="1066680"/>
          <a:ext cx="6781680" cy="5432400"/>
        </p:xfrm>
        <a:graphic>
          <a:graphicData uri="http://schemas.openxmlformats.org/drawingml/2006/table">
            <a:tbl>
              <a:tblPr/>
              <a:tblGrid>
                <a:gridCol w="1295280"/>
                <a:gridCol w="5486400"/>
              </a:tblGrid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GF-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’-CTGAGGAGTCCAACATCACCA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4f81bd"/>
                    </a:solidFill>
                  </a:tcPr>
                </a:tc>
              </a:tr>
              <a:tr h="195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’-TGTGCTGTAGGAAGCTCATCTC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’-CAAACCTCACCAAGGCC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GF-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’- GCTTAGAGCTCAACCCAGAC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’- GCTGAGTCTGAAAAGCCATGT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’- TCACCTTCGCAGCTTC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VEGF-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’- CATGAACACCAGCACGAGCTA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’- CCTTGAGAGAGAGGCACTGTAATT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’- TCAGCAAGACGTTATTT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DGF-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s Assay ID Hs00964426_m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22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DGF-B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s Assay ID Hs00966522_m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224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DGF-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s Assay ID Hs01044216_m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DGF-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’- TGTGGCTAAACCTGGATTCAAGAT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’- TCCCAGTTGGTCTCTGAAGCT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’- TTTGCTGGAAGATTTC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G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’- CGATGAGAATCTGCACTGTGT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’- GTCCCCAGAACGGATCTTTAG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’- ACGGCCAATGTCACCATG-3’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 gridSpan="2"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ference gen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FR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′-GCTTTCCCTTCCTTGCATATTC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′-GGTGGTACCCAAATAAGGATAATCTG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54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′-AATCCCAGCAGTTTCTTTCTGTTTTTGCGA-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2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′-TGAGTGCTGTCTCCATGTTTGA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′-CCACCTCTAAGTTGCCAGCC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′-TCCTAGAGCTACCTGTGGAGCAACCTGC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BP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orward primer 5′-GCCCGAAACGCCGAATA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  <a:tr h="19512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verse primer 5′-CGTGGCTCTCTTATCCTCATGA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e9edf4"/>
                    </a:solidFill>
                  </a:tcPr>
                </a:tc>
              </a:tr>
              <a:tr h="19368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porter 5′-CCCAAGCGGTTTGCTGCGGT-3′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0d8e8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1T05:25:59Z</dcterms:created>
  <dc:creator>kimh</dc:creator>
  <dc:description/>
  <dc:language>en-US</dc:language>
  <cp:lastModifiedBy>cshs</cp:lastModifiedBy>
  <dcterms:modified xsi:type="dcterms:W3CDTF">2012-12-21T22:49:25Z</dcterms:modified>
  <cp:revision>6</cp:revision>
  <dc:subject/>
  <dc:title>Supplemental Table 1    Summary of Intracellualr Signaling Study</dc:title>
</cp:coreProperties>
</file>